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84" r:id="rId2"/>
  </p:sldIdLst>
  <p:sldSz cx="28800425" cy="21599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22" d="100"/>
          <a:sy n="22" d="100"/>
        </p:scale>
        <p:origin x="1891" y="2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CF0898-E3B5-4C7E-B74A-496A186E0B2F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45354E-47BD-429C-A4D5-314F75A0542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89886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1pPr>
    <a:lvl2pPr marL="1209568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2pPr>
    <a:lvl3pPr marL="2419137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3pPr>
    <a:lvl4pPr marL="3628705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4pPr>
    <a:lvl5pPr marL="4838273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5pPr>
    <a:lvl6pPr marL="6047842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6pPr>
    <a:lvl7pPr marL="7257410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7pPr>
    <a:lvl8pPr marL="8466978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8pPr>
    <a:lvl9pPr marL="9676547" algn="l" defTabSz="2419137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A364A4-F7A8-40D8-9D68-D9012A32F542}" type="slidenum">
              <a:rPr lang="pt-BR" smtClean="0"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717022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0032" y="3534924"/>
            <a:ext cx="24480361" cy="7519835"/>
          </a:xfrm>
        </p:spPr>
        <p:txBody>
          <a:bodyPr anchor="b"/>
          <a:lstStyle>
            <a:lvl1pPr algn="ctr"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053" y="11344752"/>
            <a:ext cx="21600319" cy="5214884"/>
          </a:xfrm>
        </p:spPr>
        <p:txBody>
          <a:bodyPr/>
          <a:lstStyle>
            <a:lvl1pPr marL="0" indent="0" algn="ctr">
              <a:buNone/>
              <a:defRPr sz="7559"/>
            </a:lvl1pPr>
            <a:lvl2pPr marL="1439951" indent="0" algn="ctr">
              <a:buNone/>
              <a:defRPr sz="6299"/>
            </a:lvl2pPr>
            <a:lvl3pPr marL="2879903" indent="0" algn="ctr">
              <a:buNone/>
              <a:defRPr sz="5669"/>
            </a:lvl3pPr>
            <a:lvl4pPr marL="4319854" indent="0" algn="ctr">
              <a:buNone/>
              <a:defRPr sz="5039"/>
            </a:lvl4pPr>
            <a:lvl5pPr marL="5759806" indent="0" algn="ctr">
              <a:buNone/>
              <a:defRPr sz="5039"/>
            </a:lvl5pPr>
            <a:lvl6pPr marL="7199757" indent="0" algn="ctr">
              <a:buNone/>
              <a:defRPr sz="5039"/>
            </a:lvl6pPr>
            <a:lvl7pPr marL="8639708" indent="0" algn="ctr">
              <a:buNone/>
              <a:defRPr sz="5039"/>
            </a:lvl7pPr>
            <a:lvl8pPr marL="10079660" indent="0" algn="ctr">
              <a:buNone/>
              <a:defRPr sz="5039"/>
            </a:lvl8pPr>
            <a:lvl9pPr marL="11519611" indent="0" algn="ctr">
              <a:buNone/>
              <a:defRPr sz="5039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47268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01016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0306" y="1149975"/>
            <a:ext cx="6210092" cy="18304599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031" y="1149975"/>
            <a:ext cx="18270270" cy="18304599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95586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59230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030" y="5384888"/>
            <a:ext cx="24840367" cy="8984801"/>
          </a:xfrm>
        </p:spPr>
        <p:txBody>
          <a:bodyPr anchor="b"/>
          <a:lstStyle>
            <a:lvl1pPr>
              <a:defRPr sz="18897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030" y="14454688"/>
            <a:ext cx="24840367" cy="4724895"/>
          </a:xfrm>
        </p:spPr>
        <p:txBody>
          <a:bodyPr/>
          <a:lstStyle>
            <a:lvl1pPr marL="0" indent="0">
              <a:buNone/>
              <a:defRPr sz="7559">
                <a:solidFill>
                  <a:schemeClr val="tx1">
                    <a:tint val="82000"/>
                  </a:schemeClr>
                </a:solidFill>
              </a:defRPr>
            </a:lvl1pPr>
            <a:lvl2pPr marL="1439951" indent="0">
              <a:buNone/>
              <a:defRPr sz="6299">
                <a:solidFill>
                  <a:schemeClr val="tx1">
                    <a:tint val="82000"/>
                  </a:schemeClr>
                </a:solidFill>
              </a:defRPr>
            </a:lvl2pPr>
            <a:lvl3pPr marL="2879903" indent="0">
              <a:buNone/>
              <a:defRPr sz="5669">
                <a:solidFill>
                  <a:schemeClr val="tx1">
                    <a:tint val="82000"/>
                  </a:schemeClr>
                </a:solidFill>
              </a:defRPr>
            </a:lvl3pPr>
            <a:lvl4pPr marL="4319854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4pPr>
            <a:lvl5pPr marL="5759806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5pPr>
            <a:lvl6pPr marL="7199757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6pPr>
            <a:lvl7pPr marL="8639708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7pPr>
            <a:lvl8pPr marL="10079660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8pPr>
            <a:lvl9pPr marL="11519611" indent="0">
              <a:buNone/>
              <a:defRPr sz="5039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6719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029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0215" y="5749874"/>
            <a:ext cx="12240181" cy="1370470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67139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149979"/>
            <a:ext cx="24840367" cy="4174910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784" y="5294885"/>
            <a:ext cx="12183928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784" y="7889827"/>
            <a:ext cx="12183928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0217" y="5294885"/>
            <a:ext cx="12243932" cy="2594941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39951" indent="0">
              <a:buNone/>
              <a:defRPr sz="6299" b="1"/>
            </a:lvl2pPr>
            <a:lvl3pPr marL="2879903" indent="0">
              <a:buNone/>
              <a:defRPr sz="5669" b="1"/>
            </a:lvl3pPr>
            <a:lvl4pPr marL="4319854" indent="0">
              <a:buNone/>
              <a:defRPr sz="5039" b="1"/>
            </a:lvl4pPr>
            <a:lvl5pPr marL="5759806" indent="0">
              <a:buNone/>
              <a:defRPr sz="5039" b="1"/>
            </a:lvl5pPr>
            <a:lvl6pPr marL="7199757" indent="0">
              <a:buNone/>
              <a:defRPr sz="5039" b="1"/>
            </a:lvl6pPr>
            <a:lvl7pPr marL="8639708" indent="0">
              <a:buNone/>
              <a:defRPr sz="5039" b="1"/>
            </a:lvl7pPr>
            <a:lvl8pPr marL="10079660" indent="0">
              <a:buNone/>
              <a:defRPr sz="5039" b="1"/>
            </a:lvl8pPr>
            <a:lvl9pPr marL="11519611" indent="0">
              <a:buNone/>
              <a:defRPr sz="5039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0217" y="7889827"/>
            <a:ext cx="12243932" cy="1160474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8461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58756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29555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3932" y="3109937"/>
            <a:ext cx="14580215" cy="15349662"/>
          </a:xfrm>
        </p:spPr>
        <p:txBody>
          <a:bodyPr/>
          <a:lstStyle>
            <a:lvl1pPr>
              <a:defRPr sz="10078"/>
            </a:lvl1pPr>
            <a:lvl2pPr>
              <a:defRPr sz="8819"/>
            </a:lvl2pPr>
            <a:lvl3pPr>
              <a:defRPr sz="7559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9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439968"/>
            <a:ext cx="9288887" cy="5039889"/>
          </a:xfrm>
        </p:spPr>
        <p:txBody>
          <a:bodyPr anchor="b"/>
          <a:lstStyle>
            <a:lvl1pPr>
              <a:defRPr sz="1007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3932" y="3109937"/>
            <a:ext cx="14580215" cy="15349662"/>
          </a:xfrm>
        </p:spPr>
        <p:txBody>
          <a:bodyPr anchor="t"/>
          <a:lstStyle>
            <a:lvl1pPr marL="0" indent="0">
              <a:buNone/>
              <a:defRPr sz="10078"/>
            </a:lvl1pPr>
            <a:lvl2pPr marL="1439951" indent="0">
              <a:buNone/>
              <a:defRPr sz="8819"/>
            </a:lvl2pPr>
            <a:lvl3pPr marL="2879903" indent="0">
              <a:buNone/>
              <a:defRPr sz="7559"/>
            </a:lvl3pPr>
            <a:lvl4pPr marL="4319854" indent="0">
              <a:buNone/>
              <a:defRPr sz="6299"/>
            </a:lvl4pPr>
            <a:lvl5pPr marL="5759806" indent="0">
              <a:buNone/>
              <a:defRPr sz="6299"/>
            </a:lvl5pPr>
            <a:lvl6pPr marL="7199757" indent="0">
              <a:buNone/>
              <a:defRPr sz="6299"/>
            </a:lvl6pPr>
            <a:lvl7pPr marL="8639708" indent="0">
              <a:buNone/>
              <a:defRPr sz="6299"/>
            </a:lvl7pPr>
            <a:lvl8pPr marL="10079660" indent="0">
              <a:buNone/>
              <a:defRPr sz="6299"/>
            </a:lvl8pPr>
            <a:lvl9pPr marL="11519611" indent="0">
              <a:buNone/>
              <a:defRPr sz="6299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479857"/>
            <a:ext cx="9288887" cy="12004738"/>
          </a:xfrm>
        </p:spPr>
        <p:txBody>
          <a:bodyPr/>
          <a:lstStyle>
            <a:lvl1pPr marL="0" indent="0">
              <a:buNone/>
              <a:defRPr sz="5039"/>
            </a:lvl1pPr>
            <a:lvl2pPr marL="1439951" indent="0">
              <a:buNone/>
              <a:defRPr sz="4409"/>
            </a:lvl2pPr>
            <a:lvl3pPr marL="2879903" indent="0">
              <a:buNone/>
              <a:defRPr sz="3779"/>
            </a:lvl3pPr>
            <a:lvl4pPr marL="4319854" indent="0">
              <a:buNone/>
              <a:defRPr sz="3150"/>
            </a:lvl4pPr>
            <a:lvl5pPr marL="5759806" indent="0">
              <a:buNone/>
              <a:defRPr sz="3150"/>
            </a:lvl5pPr>
            <a:lvl6pPr marL="7199757" indent="0">
              <a:buNone/>
              <a:defRPr sz="3150"/>
            </a:lvl6pPr>
            <a:lvl7pPr marL="8639708" indent="0">
              <a:buNone/>
              <a:defRPr sz="3150"/>
            </a:lvl7pPr>
            <a:lvl8pPr marL="10079660" indent="0">
              <a:buNone/>
              <a:defRPr sz="3150"/>
            </a:lvl8pPr>
            <a:lvl9pPr marL="11519611" indent="0">
              <a:buNone/>
              <a:defRPr sz="31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49807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029" y="1149979"/>
            <a:ext cx="24840367" cy="4174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029" y="5749874"/>
            <a:ext cx="24840367" cy="13704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029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D88D35-D968-427A-BAEA-EECCBFD7C476}" type="datetimeFigureOut">
              <a:rPr lang="pt-BR" smtClean="0"/>
              <a:t>20/11/2025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0141" y="20019564"/>
            <a:ext cx="9720143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0300" y="20019564"/>
            <a:ext cx="6480096" cy="11499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7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10CC4E-7B55-4A1C-B2A3-C1C95F560BA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4131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879903" rtl="0" eaLnBrk="1" latinLnBrk="0" hangingPunct="1">
        <a:lnSpc>
          <a:spcPct val="90000"/>
        </a:lnSpc>
        <a:spcBef>
          <a:spcPct val="0"/>
        </a:spcBef>
        <a:buNone/>
        <a:defRPr sz="13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19976" indent="-719976" algn="l" defTabSz="2879903" rtl="0" eaLnBrk="1" latinLnBrk="0" hangingPunct="1">
        <a:lnSpc>
          <a:spcPct val="90000"/>
        </a:lnSpc>
        <a:spcBef>
          <a:spcPts val="3150"/>
        </a:spcBef>
        <a:buFont typeface="Arial" panose="020B0604020202020204" pitchFamily="34" charset="0"/>
        <a:buChar char="•"/>
        <a:defRPr sz="8819" kern="1200">
          <a:solidFill>
            <a:schemeClr val="tx1"/>
          </a:solidFill>
          <a:latin typeface="+mn-lt"/>
          <a:ea typeface="+mn-ea"/>
          <a:cs typeface="+mn-cs"/>
        </a:defRPr>
      </a:lvl1pPr>
      <a:lvl2pPr marL="215992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7559" kern="1200">
          <a:solidFill>
            <a:schemeClr val="tx1"/>
          </a:solidFill>
          <a:latin typeface="+mn-lt"/>
          <a:ea typeface="+mn-ea"/>
          <a:cs typeface="+mn-cs"/>
        </a:defRPr>
      </a:lvl2pPr>
      <a:lvl3pPr marL="3599879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6299" kern="1200">
          <a:solidFill>
            <a:schemeClr val="tx1"/>
          </a:solidFill>
          <a:latin typeface="+mn-lt"/>
          <a:ea typeface="+mn-ea"/>
          <a:cs typeface="+mn-cs"/>
        </a:defRPr>
      </a:lvl3pPr>
      <a:lvl4pPr marL="5039830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6479781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919733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9359684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799636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2239587" indent="-719976" algn="l" defTabSz="2879903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1pPr>
      <a:lvl2pPr marL="143995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879903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3pPr>
      <a:lvl4pPr marL="4319854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5759806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199757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8639708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079660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1519611" algn="l" defTabSz="2879903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>
            <a:extLst>
              <a:ext uri="{FF2B5EF4-FFF2-40B4-BE49-F238E27FC236}">
                <a16:creationId xmlns:a16="http://schemas.microsoft.com/office/drawing/2014/main" id="{D62916E6-8E7B-02E6-300A-16544A8FD4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74581"/>
            <a:ext cx="28356923" cy="8998019"/>
          </a:xfrm>
          <a:prstGeom prst="rect">
            <a:avLst/>
          </a:prstGeom>
        </p:spPr>
      </p:pic>
      <p:sp>
        <p:nvSpPr>
          <p:cNvPr id="3" name="CaixaDeTexto 2">
            <a:extLst>
              <a:ext uri="{FF2B5EF4-FFF2-40B4-BE49-F238E27FC236}">
                <a16:creationId xmlns:a16="http://schemas.microsoft.com/office/drawing/2014/main" id="{7221F6DF-085A-1D13-0904-BB341A56274C}"/>
              </a:ext>
            </a:extLst>
          </p:cNvPr>
          <p:cNvSpPr txBox="1"/>
          <p:nvPr/>
        </p:nvSpPr>
        <p:spPr>
          <a:xfrm>
            <a:off x="443501" y="10370199"/>
            <a:ext cx="27913421" cy="297478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32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4. Purity assessment of CD19⁺ B cells used for adoptive transfer experiments.</a:t>
            </a:r>
            <a:r>
              <a:rPr lang="en-US" sz="3200" b="1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low cytometry plots showing representative gating strategy and enrichment efficiency of BM–derived CD19⁺ B cells isolated from 67NR tumor–bearing mice. Cells were labeled with anti-CD19 and anti-CD3 antibodies and analyzed before purification (left), after magnetic separation (middle), and following CD19</a:t>
            </a:r>
            <a:r>
              <a:rPr lang="en-US" sz="3200" kern="100" baseline="300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B cells enrichment (right). The final purity of CD19⁺ B cells used in adoptive transfer experiments exceeded 96%, with minimal CD3⁺ T-cell contamination (&lt;1%). Data are representative of independent purifications used across experiments.</a:t>
            </a:r>
            <a:endParaRPr lang="pt-BR" sz="2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76756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10</Words>
  <Application>Microsoft Office PowerPoint</Application>
  <PresentationFormat>Personalizar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 Monteiro</dc:creator>
  <cp:lastModifiedBy>Ana Monteiro</cp:lastModifiedBy>
  <cp:revision>4</cp:revision>
  <dcterms:created xsi:type="dcterms:W3CDTF">2025-11-20T17:53:58Z</dcterms:created>
  <dcterms:modified xsi:type="dcterms:W3CDTF">2025-11-20T17:57:18Z</dcterms:modified>
</cp:coreProperties>
</file>